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9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9080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6993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0317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6934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267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332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1158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400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4359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4987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2251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683B56-BAC8-4722-BA67-7BE8BFDA9DE1}" type="datetimeFigureOut">
              <a:rPr lang="fr-FR" smtClean="0"/>
              <a:t>20/05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99630-17B0-4F64-A330-EDBB77BD773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8917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9C21D570-B7EB-E446-8FCA-2D1324510921}"/>
              </a:ext>
            </a:extLst>
          </p:cNvPr>
          <p:cNvSpPr txBox="1"/>
          <p:nvPr/>
        </p:nvSpPr>
        <p:spPr>
          <a:xfrm>
            <a:off x="335667" y="92597"/>
            <a:ext cx="992124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0" dirty="0">
                <a:effectLst/>
              </a:rPr>
              <a:t/>
            </a:r>
            <a:br>
              <a:rPr lang="fr-FR" b="0" dirty="0">
                <a:effectLst/>
              </a:rPr>
            </a:br>
            <a:r>
              <a:rPr lang="fr-FR" sz="14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fr-FR" sz="14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pplementary</a:t>
            </a:r>
            <a:r>
              <a:rPr lang="fr-FR" sz="14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Figure 1.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Standardized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mean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difference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(SMD) plot</a:t>
            </a:r>
            <a:r>
              <a:rPr lang="fr-FR" sz="1400" dirty="0">
                <a:latin typeface="Times New Roman" panose="02020603050405020304" pitchFamily="18" charset="0"/>
              </a:rPr>
              <a:t> o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f IPTW for intubation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analysi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</a:p>
          <a:p>
            <a:r>
              <a:rPr lang="fr-FR" sz="1400" dirty="0" err="1">
                <a:effectLst/>
                <a:latin typeface="Times New Roman" panose="02020603050405020304" pitchFamily="18" charset="0"/>
              </a:rPr>
              <a:t>Red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circle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denote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Standardized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mean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difference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(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SMD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)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before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weighting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the inverse of the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probability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of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treatment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weight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(IPTW). </a:t>
            </a:r>
          </a:p>
          <a:p>
            <a:r>
              <a:rPr lang="fr-FR" sz="1400" dirty="0">
                <a:effectLst/>
                <a:latin typeface="Times New Roman" panose="02020603050405020304" pitchFamily="18" charset="0"/>
              </a:rPr>
              <a:t>Blue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circle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denote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the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SMD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after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weighting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the IPTW. 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08A33626-2A2A-2245-AFD2-F142AE9537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49600" y="1309688"/>
            <a:ext cx="5892800" cy="4838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5059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9C21D570-B7EB-E446-8FCA-2D1324510921}"/>
              </a:ext>
            </a:extLst>
          </p:cNvPr>
          <p:cNvSpPr txBox="1"/>
          <p:nvPr/>
        </p:nvSpPr>
        <p:spPr>
          <a:xfrm>
            <a:off x="335667" y="92597"/>
            <a:ext cx="992124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0" dirty="0">
                <a:effectLst/>
              </a:rPr>
              <a:t/>
            </a:r>
            <a:br>
              <a:rPr lang="fr-FR" b="0" dirty="0">
                <a:effectLst/>
              </a:rPr>
            </a:br>
            <a:r>
              <a:rPr lang="fr-FR" sz="14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fr-FR" sz="14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pplementary</a:t>
            </a:r>
            <a:r>
              <a:rPr lang="fr-FR" sz="14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Figure 2.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Standardized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mean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difference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(SMD) plot</a:t>
            </a:r>
            <a:r>
              <a:rPr lang="fr-FR" sz="1400" dirty="0">
                <a:latin typeface="Times New Roman" panose="02020603050405020304" pitchFamily="18" charset="0"/>
              </a:rPr>
              <a:t> o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f IPTW for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survival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analysi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</a:p>
          <a:p>
            <a:r>
              <a:rPr lang="fr-FR" sz="1400" dirty="0" err="1">
                <a:effectLst/>
                <a:latin typeface="Times New Roman" panose="02020603050405020304" pitchFamily="18" charset="0"/>
              </a:rPr>
              <a:t>Red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circle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denote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Standardized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mean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difference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(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SMD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)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before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weighting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the inverse of the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probability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of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treatment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weight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(IPTW). </a:t>
            </a:r>
          </a:p>
          <a:p>
            <a:r>
              <a:rPr lang="fr-FR" sz="1400" dirty="0">
                <a:effectLst/>
                <a:latin typeface="Times New Roman" panose="02020603050405020304" pitchFamily="18" charset="0"/>
              </a:rPr>
              <a:t>Blue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circle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denote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the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SMDs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after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Times New Roman" panose="02020603050405020304" pitchFamily="18" charset="0"/>
              </a:rPr>
              <a:t>weighting</a:t>
            </a:r>
            <a:r>
              <a:rPr lang="fr-FR" sz="1400" dirty="0">
                <a:effectLst/>
                <a:latin typeface="Times New Roman" panose="02020603050405020304" pitchFamily="18" charset="0"/>
              </a:rPr>
              <a:t> the IPTW. 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D1C7916E-0E05-E348-A9B6-CE2D9E7A27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6350" y="1315089"/>
            <a:ext cx="7099300" cy="51317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03041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82B62926-1C3C-A74C-98AC-CB1E82298B03}"/>
              </a:ext>
            </a:extLst>
          </p:cNvPr>
          <p:cNvSpPr txBox="1"/>
          <p:nvPr/>
        </p:nvSpPr>
        <p:spPr>
          <a:xfrm>
            <a:off x="122730" y="185528"/>
            <a:ext cx="11290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fr-FR" sz="14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pplementary</a:t>
            </a:r>
            <a:r>
              <a:rPr lang="fr-FR" sz="14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Figure 3. </a:t>
            </a:r>
            <a:r>
              <a:rPr lang="fr-FR" sz="14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Weighted</a:t>
            </a:r>
            <a:r>
              <a:rPr lang="fr-FR" sz="14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fr-FR" sz="1400" dirty="0">
                <a:solidFill>
                  <a:srgbClr val="000000"/>
                </a:solidFill>
                <a:latin typeface="Times New Roman" panose="02020603050405020304" pitchFamily="18" charset="0"/>
              </a:rPr>
              <a:t>c</a:t>
            </a:r>
            <a:r>
              <a:rPr lang="fr-FR" sz="14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umulative incidence of </a:t>
            </a:r>
            <a:r>
              <a:rPr lang="fr-FR" sz="14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eath</a:t>
            </a:r>
            <a:r>
              <a:rPr lang="fr-FR" sz="14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in </a:t>
            </a:r>
            <a:r>
              <a:rPr lang="fr-FR" sz="14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ritically</a:t>
            </a:r>
            <a:r>
              <a:rPr lang="fr-FR" sz="14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fr-FR" sz="14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ill</a:t>
            </a:r>
            <a:r>
              <a:rPr lang="fr-FR" sz="14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fr-FR" sz="14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neumocystis</a:t>
            </a:r>
            <a:r>
              <a:rPr lang="fr-FR" sz="14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fr-FR" sz="14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neumonia</a:t>
            </a:r>
            <a:r>
              <a:rPr lang="fr-FR" sz="14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atients </a:t>
            </a:r>
            <a:r>
              <a:rPr lang="fr-FR" sz="14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ccording</a:t>
            </a:r>
            <a:r>
              <a:rPr lang="fr-FR" sz="14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to </a:t>
            </a:r>
            <a:r>
              <a:rPr lang="fr-FR" sz="140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respiratory</a:t>
            </a:r>
            <a:r>
              <a:rPr lang="fr-FR" sz="14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management</a:t>
            </a:r>
            <a:endParaRPr lang="fr-FR" sz="1400" dirty="0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001A09D7-5A12-6348-8C42-55DADBDCF4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8050" y="596900"/>
            <a:ext cx="7835900" cy="5664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01322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Grand écran</PresentationFormat>
  <Paragraphs>7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Company>CH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EIZINE Florian</dc:creator>
  <cp:lastModifiedBy>REIZINE Florian</cp:lastModifiedBy>
  <cp:revision>1</cp:revision>
  <dcterms:created xsi:type="dcterms:W3CDTF">2025-05-20T12:10:16Z</dcterms:created>
  <dcterms:modified xsi:type="dcterms:W3CDTF">2025-05-20T12:10:37Z</dcterms:modified>
</cp:coreProperties>
</file>